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1117" autoAdjust="0"/>
  </p:normalViewPr>
  <p:slideViewPr>
    <p:cSldViewPr snapToGrid="0">
      <p:cViewPr varScale="1">
        <p:scale>
          <a:sx n="68" d="100"/>
          <a:sy n="68" d="100"/>
        </p:scale>
        <p:origin x="81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7EL%20sequence%20and%20RNAseq%20paper\Copy%20of%20A5GT_10W273_1.xls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F:\7EL%20sequence%20and%20RNAseq%20paper\Copy%20of%20Norm_3Ta_WRKY.xls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F:\7EL%20sequence%20and%20RNAseq%20paper\Copy%20of%20Norm_3Ta_Ta24746.xls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F:\7EL%20sequence%20and%20RNAseq%20paper\Copy%20of%20Norm_3Ta_zinc_finger.xls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CA"/>
              <a:t>Glucosyltransferase</a:t>
            </a:r>
            <a:r>
              <a:rPr lang="en-CA" baseline="0"/>
              <a:t> (MSTRG.21806)</a:t>
            </a:r>
            <a:endParaRPr lang="en-CA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OLUTION!$S$41:$S$45</c:f>
                <c:numCache>
                  <c:formatCode>General</c:formatCode>
                  <c:ptCount val="5"/>
                  <c:pt idx="0">
                    <c:v>7.06</c:v>
                  </c:pt>
                  <c:pt idx="1">
                    <c:v>1.2</c:v>
                  </c:pt>
                  <c:pt idx="3">
                    <c:v>6.03</c:v>
                  </c:pt>
                  <c:pt idx="4">
                    <c:v>3.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OLUTION!$Q$41:$Q$45</c:f>
              <c:strCache>
                <c:ptCount val="5"/>
                <c:pt idx="0">
                  <c:v>CS-Fg</c:v>
                </c:pt>
                <c:pt idx="1">
                  <c:v>CS-H2O</c:v>
                </c:pt>
                <c:pt idx="3">
                  <c:v>CS-7EL-Fg</c:v>
                </c:pt>
                <c:pt idx="4">
                  <c:v>CS-7EL-H2O</c:v>
                </c:pt>
              </c:strCache>
            </c:strRef>
          </c:cat>
          <c:val>
            <c:numRef>
              <c:f>SOLUTION!$R$41:$R$45</c:f>
              <c:numCache>
                <c:formatCode>General</c:formatCode>
                <c:ptCount val="5"/>
                <c:pt idx="0">
                  <c:v>29.295000000000002</c:v>
                </c:pt>
                <c:pt idx="1">
                  <c:v>2.9849999999999999</c:v>
                </c:pt>
                <c:pt idx="3">
                  <c:v>18.015000000000001</c:v>
                </c:pt>
                <c:pt idx="4">
                  <c:v>3.61500000000000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35D-42B6-9E39-D2BBBF34F1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1493696"/>
        <c:axId val="75047144"/>
      </c:barChart>
      <c:catAx>
        <c:axId val="1214936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5047144"/>
        <c:crosses val="autoZero"/>
        <c:auto val="1"/>
        <c:lblAlgn val="ctr"/>
        <c:lblOffset val="100"/>
        <c:noMultiLvlLbl val="0"/>
      </c:catAx>
      <c:valAx>
        <c:axId val="750471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rgbClr val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14936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CA"/>
              <a:t>WRKY79 (MSTRG.</a:t>
            </a:r>
            <a:r>
              <a:rPr lang="en-CA" sz="1400" b="0" i="0" u="none" strike="noStrike" baseline="0">
                <a:effectLst/>
              </a:rPr>
              <a:t>145180)</a:t>
            </a:r>
            <a:endParaRPr lang="en-CA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OLUTION!$G$61:$G$65</c:f>
                <c:numCache>
                  <c:formatCode>General</c:formatCode>
                  <c:ptCount val="5"/>
                  <c:pt idx="0">
                    <c:v>1699.8</c:v>
                  </c:pt>
                  <c:pt idx="1">
                    <c:v>0.92</c:v>
                  </c:pt>
                  <c:pt idx="3">
                    <c:v>202</c:v>
                  </c:pt>
                  <c:pt idx="4">
                    <c:v>0.6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OLUTION!$E$61:$E$65</c:f>
              <c:strCache>
                <c:ptCount val="5"/>
                <c:pt idx="0">
                  <c:v>CS-Fg</c:v>
                </c:pt>
                <c:pt idx="1">
                  <c:v>CS-H2O</c:v>
                </c:pt>
                <c:pt idx="3">
                  <c:v>CS-7EL-Fg</c:v>
                </c:pt>
                <c:pt idx="4">
                  <c:v>CS-7EL-H2O</c:v>
                </c:pt>
              </c:strCache>
            </c:strRef>
          </c:cat>
          <c:val>
            <c:numRef>
              <c:f>SOLUTION!$F$61:$F$65</c:f>
              <c:numCache>
                <c:formatCode>General</c:formatCode>
                <c:ptCount val="5"/>
                <c:pt idx="0">
                  <c:v>10043.6</c:v>
                </c:pt>
                <c:pt idx="1">
                  <c:v>2.0299999999999998</c:v>
                </c:pt>
                <c:pt idx="3">
                  <c:v>945.2</c:v>
                </c:pt>
                <c:pt idx="4">
                  <c:v>1.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60E8-4DF5-A9E2-ED91AC66168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9704368"/>
        <c:axId val="169704752"/>
      </c:barChart>
      <c:catAx>
        <c:axId val="1697043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9704752"/>
        <c:crosses val="autoZero"/>
        <c:auto val="1"/>
        <c:lblAlgn val="ctr"/>
        <c:lblOffset val="100"/>
        <c:noMultiLvlLbl val="0"/>
      </c:catAx>
      <c:valAx>
        <c:axId val="169704752"/>
        <c:scaling>
          <c:orientation val="minMax"/>
          <c:max val="120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accent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97043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CA" sz="1400" b="0" i="0" u="none" strike="noStrike" baseline="0">
                <a:effectLst/>
              </a:rPr>
              <a:t>E3 ubiquitin-protein ligase (MSTRTG.70787)</a:t>
            </a:r>
            <a:endParaRPr lang="en-CA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OLUTION!$L$49:$L$53</c:f>
                <c:numCache>
                  <c:formatCode>General</c:formatCode>
                  <c:ptCount val="5"/>
                  <c:pt idx="0">
                    <c:v>2.0668160502724175</c:v>
                  </c:pt>
                  <c:pt idx="1">
                    <c:v>1.4451999510899094</c:v>
                  </c:pt>
                  <c:pt idx="3">
                    <c:v>0.67689037814794772</c:v>
                  </c:pt>
                  <c:pt idx="4">
                    <c:v>2.678602443682402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OLUTION!$J$49:$J$53</c:f>
              <c:strCache>
                <c:ptCount val="5"/>
                <c:pt idx="0">
                  <c:v>CS-Fg</c:v>
                </c:pt>
                <c:pt idx="1">
                  <c:v>CS-H2O</c:v>
                </c:pt>
                <c:pt idx="3">
                  <c:v>CS-7EL-Fg</c:v>
                </c:pt>
                <c:pt idx="4">
                  <c:v>CS-7EL-H2O</c:v>
                </c:pt>
              </c:strCache>
            </c:strRef>
          </c:cat>
          <c:val>
            <c:numRef>
              <c:f>SOLUTION!$K$49:$K$53</c:f>
              <c:numCache>
                <c:formatCode>General</c:formatCode>
                <c:ptCount val="5"/>
                <c:pt idx="0">
                  <c:v>2.495669924437002</c:v>
                </c:pt>
                <c:pt idx="1">
                  <c:v>18.590036014272023</c:v>
                </c:pt>
                <c:pt idx="3">
                  <c:v>5.2033457637140144</c:v>
                </c:pt>
                <c:pt idx="4">
                  <c:v>10.2887734540254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106-4163-BA3F-AD96318A21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9164864"/>
        <c:axId val="169185624"/>
      </c:barChart>
      <c:catAx>
        <c:axId val="1691648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9185624"/>
        <c:crosses val="autoZero"/>
        <c:auto val="1"/>
        <c:lblAlgn val="ctr"/>
        <c:lblOffset val="100"/>
        <c:noMultiLvlLbl val="0"/>
      </c:catAx>
      <c:valAx>
        <c:axId val="1691856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91648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CA" sz="1400" b="0" i="0" u="none" strike="noStrike" baseline="0">
                <a:effectLst/>
              </a:rPr>
              <a:t>Zinc finger protein ZAT (MSTRG.60974)</a:t>
            </a:r>
            <a:endParaRPr lang="en-CA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OLUTION!$L$51:$L$55</c:f>
                <c:numCache>
                  <c:formatCode>General</c:formatCode>
                  <c:ptCount val="5"/>
                  <c:pt idx="0">
                    <c:v>155.35689470944604</c:v>
                  </c:pt>
                  <c:pt idx="1">
                    <c:v>2.0731383301664863</c:v>
                  </c:pt>
                  <c:pt idx="3">
                    <c:v>6.8443586208631038</c:v>
                  </c:pt>
                  <c:pt idx="4">
                    <c:v>7.243199129563886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OLUTION!$J$51:$J$55</c:f>
              <c:strCache>
                <c:ptCount val="5"/>
                <c:pt idx="0">
                  <c:v>CS-Fg</c:v>
                </c:pt>
                <c:pt idx="1">
                  <c:v>CS-H2O</c:v>
                </c:pt>
                <c:pt idx="3">
                  <c:v>CS-7EL-Fg</c:v>
                </c:pt>
                <c:pt idx="4">
                  <c:v>CS-7EL-H2O</c:v>
                </c:pt>
              </c:strCache>
            </c:strRef>
          </c:cat>
          <c:val>
            <c:numRef>
              <c:f>SOLUTION!$K$51:$K$55</c:f>
              <c:numCache>
                <c:formatCode>General</c:formatCode>
                <c:ptCount val="5"/>
                <c:pt idx="0">
                  <c:v>797.64217437954323</c:v>
                </c:pt>
                <c:pt idx="1">
                  <c:v>4.6848938301930971</c:v>
                </c:pt>
                <c:pt idx="3">
                  <c:v>57.055597921102809</c:v>
                </c:pt>
                <c:pt idx="4">
                  <c:v>7.22524705947127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C0C-468A-ABC3-70D3F711367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1307064"/>
        <c:axId val="121305496"/>
      </c:barChart>
      <c:catAx>
        <c:axId val="1213070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1305496"/>
        <c:crosses val="autoZero"/>
        <c:auto val="1"/>
        <c:lblAlgn val="ctr"/>
        <c:lblOffset val="100"/>
        <c:noMultiLvlLbl val="0"/>
      </c:catAx>
      <c:valAx>
        <c:axId val="1213054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13070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9421D-3E86-40BD-96FF-B95CA1D0AB77}" type="datetimeFigureOut">
              <a:rPr lang="en-CA" smtClean="0"/>
              <a:t>2021-11-3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F1779-1891-4808-AD9B-84BD372B35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07370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9421D-3E86-40BD-96FF-B95CA1D0AB77}" type="datetimeFigureOut">
              <a:rPr lang="en-CA" smtClean="0"/>
              <a:t>2021-11-3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F1779-1891-4808-AD9B-84BD372B35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734520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9421D-3E86-40BD-96FF-B95CA1D0AB77}" type="datetimeFigureOut">
              <a:rPr lang="en-CA" smtClean="0"/>
              <a:t>2021-11-3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F1779-1891-4808-AD9B-84BD372B35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945591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9421D-3E86-40BD-96FF-B95CA1D0AB77}" type="datetimeFigureOut">
              <a:rPr lang="en-CA" smtClean="0"/>
              <a:t>2021-11-3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F1779-1891-4808-AD9B-84BD372B35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997472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9421D-3E86-40BD-96FF-B95CA1D0AB77}" type="datetimeFigureOut">
              <a:rPr lang="en-CA" smtClean="0"/>
              <a:t>2021-11-3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F1779-1891-4808-AD9B-84BD372B35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288493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9421D-3E86-40BD-96FF-B95CA1D0AB77}" type="datetimeFigureOut">
              <a:rPr lang="en-CA" smtClean="0"/>
              <a:t>2021-11-3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F1779-1891-4808-AD9B-84BD372B35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811840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9421D-3E86-40BD-96FF-B95CA1D0AB77}" type="datetimeFigureOut">
              <a:rPr lang="en-CA" smtClean="0"/>
              <a:t>2021-11-30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F1779-1891-4808-AD9B-84BD372B35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328427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9421D-3E86-40BD-96FF-B95CA1D0AB77}" type="datetimeFigureOut">
              <a:rPr lang="en-CA" smtClean="0"/>
              <a:t>2021-11-30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F1779-1891-4808-AD9B-84BD372B35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098576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9421D-3E86-40BD-96FF-B95CA1D0AB77}" type="datetimeFigureOut">
              <a:rPr lang="en-CA" smtClean="0"/>
              <a:t>2021-11-30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F1779-1891-4808-AD9B-84BD372B35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668777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9421D-3E86-40BD-96FF-B95CA1D0AB77}" type="datetimeFigureOut">
              <a:rPr lang="en-CA" smtClean="0"/>
              <a:t>2021-11-3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F1779-1891-4808-AD9B-84BD372B35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280198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9421D-3E86-40BD-96FF-B95CA1D0AB77}" type="datetimeFigureOut">
              <a:rPr lang="en-CA" smtClean="0"/>
              <a:t>2021-11-3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F1779-1891-4808-AD9B-84BD372B35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456203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69421D-3E86-40BD-96FF-B95CA1D0AB77}" type="datetimeFigureOut">
              <a:rPr lang="en-CA" smtClean="0"/>
              <a:t>2021-11-3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2F1779-1891-4808-AD9B-84BD372B35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596690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28182868"/>
              </p:ext>
            </p:extLst>
          </p:nvPr>
        </p:nvGraphicFramePr>
        <p:xfrm>
          <a:off x="6328989" y="255817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14409551"/>
              </p:ext>
            </p:extLst>
          </p:nvPr>
        </p:nvGraphicFramePr>
        <p:xfrm>
          <a:off x="1621761" y="255817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35202367"/>
              </p:ext>
            </p:extLst>
          </p:nvPr>
        </p:nvGraphicFramePr>
        <p:xfrm>
          <a:off x="6328989" y="3047312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19094964"/>
              </p:ext>
            </p:extLst>
          </p:nvPr>
        </p:nvGraphicFramePr>
        <p:xfrm>
          <a:off x="1621761" y="3047312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390698" y="5902032"/>
            <a:ext cx="1157547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dditional file 12. </a:t>
            </a:r>
            <a:r>
              <a:rPr lang="en-CA" dirty="0" smtClean="0"/>
              <a:t>Relative </a:t>
            </a:r>
            <a:r>
              <a:rPr lang="en-CA" dirty="0"/>
              <a:t>expression </a:t>
            </a:r>
            <a:r>
              <a:rPr lang="en-CA" dirty="0" smtClean="0"/>
              <a:t>(Y-axis) of </a:t>
            </a:r>
            <a:r>
              <a:rPr lang="en-CA" dirty="0"/>
              <a:t>four DE wheat genes as measured by RT-qPCR analysis. CS CS-7EL lines were sampled after 4d of treatment with water (H2O) or inoculation with </a:t>
            </a:r>
            <a:r>
              <a:rPr lang="en-CA" i="1" dirty="0"/>
              <a:t>F. graminearum</a:t>
            </a:r>
            <a:r>
              <a:rPr lang="en-CA" dirty="0"/>
              <a:t> spores (</a:t>
            </a:r>
            <a:r>
              <a:rPr lang="en-CA" dirty="0" err="1"/>
              <a:t>Fg</a:t>
            </a:r>
            <a:r>
              <a:rPr lang="en-CA" dirty="0"/>
              <a:t>). Values are mean of three biological replicates; error bars represent standard deviation. </a:t>
            </a:r>
          </a:p>
          <a:p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25654066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9</TotalTime>
  <Words>79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erese</dc:creator>
  <cp:lastModifiedBy>Therese</cp:lastModifiedBy>
  <cp:revision>16</cp:revision>
  <dcterms:created xsi:type="dcterms:W3CDTF">2021-03-02T20:28:28Z</dcterms:created>
  <dcterms:modified xsi:type="dcterms:W3CDTF">2021-11-30T16:58:41Z</dcterms:modified>
</cp:coreProperties>
</file>